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082" autoAdjust="0"/>
    <p:restoredTop sz="77000" autoAdjust="0"/>
  </p:normalViewPr>
  <p:slideViewPr>
    <p:cSldViewPr snapToGrid="0" snapToObjects="1">
      <p:cViewPr varScale="1">
        <p:scale>
          <a:sx n="62" d="100"/>
          <a:sy n="62" d="100"/>
        </p:scale>
        <p:origin x="-231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FB776-10CD-FB47-94DC-710F9875BE93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5DAEED-EE94-604F-9056-72416A585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19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l 10: Full Ki67 staining of HCT116 xenografts. </a:t>
            </a:r>
            <a:r>
              <a:rPr lang="en-US" b="0" dirty="0"/>
              <a:t>Representative IHC staining of Ki67 expression from mice treated with indicated drugs. Tumors harvested and placed in paraffin. </a:t>
            </a:r>
            <a:r>
              <a:rPr lang="en-US" altLang="en-US" dirty="0"/>
              <a:t>ONC201: 50mg/kg every week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vacizumab</a:t>
            </a:r>
            <a:r>
              <a:rPr lang="en-US" altLang="en-US" dirty="0"/>
              <a:t>: 5mg/kg every other week. Regorafenib: 5mg/kg daily N=5 tumors, minimum of 3 sections per tumor stained.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34B4C1-4FF2-4F6E-AD9F-C3425F53B084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43712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515B7B-69FE-D941-9EAE-512165C8B66C}" type="datetimeFigureOut">
              <a:rPr lang="en-US" smtClean="0"/>
              <a:t>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638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B4ABA85-0B49-4FB3-8AB8-F5206076DA0B}"/>
              </a:ext>
            </a:extLst>
          </p:cNvPr>
          <p:cNvSpPr txBox="1"/>
          <p:nvPr/>
        </p:nvSpPr>
        <p:spPr>
          <a:xfrm rot="16200000">
            <a:off x="115344" y="2732994"/>
            <a:ext cx="12102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u="sng" dirty="0"/>
              <a:t>ONC20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17FED37C-38C8-423B-9FED-1DE8C2530251}"/>
              </a:ext>
            </a:extLst>
          </p:cNvPr>
          <p:cNvSpPr txBox="1"/>
          <p:nvPr/>
        </p:nvSpPr>
        <p:spPr>
          <a:xfrm rot="16200000">
            <a:off x="-101941" y="3978961"/>
            <a:ext cx="17003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u="sng" dirty="0"/>
              <a:t>Bevacizuma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9BCDD30F-4C1B-4DAC-9289-5F9255597CD2}"/>
              </a:ext>
            </a:extLst>
          </p:cNvPr>
          <p:cNvSpPr txBox="1"/>
          <p:nvPr/>
        </p:nvSpPr>
        <p:spPr>
          <a:xfrm rot="16200000">
            <a:off x="133847" y="1458978"/>
            <a:ext cx="12037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u="sng" dirty="0"/>
              <a:t>Vehicl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066EC9A5-B9B8-4CF6-A456-A834FEC64314}"/>
              </a:ext>
            </a:extLst>
          </p:cNvPr>
          <p:cNvSpPr txBox="1"/>
          <p:nvPr/>
        </p:nvSpPr>
        <p:spPr>
          <a:xfrm rot="16200000">
            <a:off x="48734" y="5158362"/>
            <a:ext cx="12039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u="sng" dirty="0"/>
              <a:t>Bev. + ONC20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C0CF3DE7-ABD1-4CD8-AF05-D78CF6BEC1C2}"/>
              </a:ext>
            </a:extLst>
          </p:cNvPr>
          <p:cNvSpPr txBox="1"/>
          <p:nvPr/>
        </p:nvSpPr>
        <p:spPr>
          <a:xfrm>
            <a:off x="1381357" y="646304"/>
            <a:ext cx="16198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10x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1891621C-24DB-42CF-AC4E-314C33684157}"/>
              </a:ext>
            </a:extLst>
          </p:cNvPr>
          <p:cNvSpPr txBox="1"/>
          <p:nvPr/>
        </p:nvSpPr>
        <p:spPr>
          <a:xfrm>
            <a:off x="3236461" y="646304"/>
            <a:ext cx="16198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40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DCD25DEE-D4B3-4FA4-A10C-95C36C64F46D}"/>
              </a:ext>
            </a:extLst>
          </p:cNvPr>
          <p:cNvSpPr txBox="1"/>
          <p:nvPr/>
        </p:nvSpPr>
        <p:spPr>
          <a:xfrm>
            <a:off x="976980" y="69820"/>
            <a:ext cx="38793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Ki6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2E331E6-5117-4B58-AA98-550ABFD0781A}"/>
              </a:ext>
            </a:extLst>
          </p:cNvPr>
          <p:cNvSpPr txBox="1"/>
          <p:nvPr/>
        </p:nvSpPr>
        <p:spPr>
          <a:xfrm>
            <a:off x="968627" y="455307"/>
            <a:ext cx="38876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u="sng" dirty="0"/>
              <a:t>HCT11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B33ADB15-3C68-4FA8-9EBD-1977FEAC5340}"/>
              </a:ext>
            </a:extLst>
          </p:cNvPr>
          <p:cNvSpPr txBox="1"/>
          <p:nvPr/>
        </p:nvSpPr>
        <p:spPr>
          <a:xfrm rot="16200000">
            <a:off x="136708" y="6598335"/>
            <a:ext cx="11941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u="sng" dirty="0" err="1"/>
              <a:t>Regor</a:t>
            </a:r>
            <a:r>
              <a:rPr lang="en-US" sz="2000" u="sng" dirty="0"/>
              <a:t>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E308D2A4-D7D6-44EA-BEED-16AFF9AFE978}"/>
              </a:ext>
            </a:extLst>
          </p:cNvPr>
          <p:cNvSpPr txBox="1"/>
          <p:nvPr/>
        </p:nvSpPr>
        <p:spPr>
          <a:xfrm rot="16200000">
            <a:off x="62277" y="7727391"/>
            <a:ext cx="1210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u="sng" dirty="0" err="1"/>
              <a:t>Regor</a:t>
            </a:r>
            <a:r>
              <a:rPr lang="en-US" sz="2000" u="sng" dirty="0"/>
              <a:t>.  + ONC201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25DBF600-6BBD-4838-82F8-C31BEBFEAF35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357" y="1050669"/>
            <a:ext cx="1619854" cy="121023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62A4B393-E1F9-4742-84C3-E2F6AE46EF49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461" y="1057160"/>
            <a:ext cx="1619854" cy="121023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6EC0D7EE-B653-4CD2-BF96-C82372C30075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357" y="2331875"/>
            <a:ext cx="1619854" cy="121023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97C06588-4211-4CD1-9F95-FF063ADD072A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461" y="2327930"/>
            <a:ext cx="1619854" cy="121023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22716CD1-BF59-42D5-9AAB-6425826FC471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4460" y="3613082"/>
            <a:ext cx="1619854" cy="1210235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xmlns="" id="{1EDB71E8-29A5-4185-B8EA-F6BBB6F69BC9}"/>
              </a:ext>
            </a:extLst>
          </p:cNvPr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461" y="3619129"/>
            <a:ext cx="1619854" cy="1210235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17C60C17-007B-4EB3-B143-E41B898AC189}"/>
              </a:ext>
            </a:extLst>
          </p:cNvPr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357" y="4904045"/>
            <a:ext cx="1619854" cy="1210235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A038566D-8958-44BC-9F9B-2EF528321BAB}"/>
              </a:ext>
            </a:extLst>
          </p:cNvPr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461" y="4910327"/>
            <a:ext cx="1619854" cy="1210235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E62ED9F0-D137-4EE1-A72C-657B6D8F6E19}"/>
              </a:ext>
            </a:extLst>
          </p:cNvPr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461" y="6185252"/>
            <a:ext cx="1619854" cy="121023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xmlns="" id="{704B8BE0-AAE0-4C75-9BE5-4C5F065F302E}"/>
              </a:ext>
            </a:extLst>
          </p:cNvPr>
          <p:cNvPicPr>
            <a:picLocks noChangeAspect="1"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357" y="6185252"/>
            <a:ext cx="1619854" cy="121023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xmlns="" id="{0BE9C158-3F69-4AF3-8CF0-4C78D99FE8D1}"/>
              </a:ext>
            </a:extLst>
          </p:cNvPr>
          <p:cNvPicPr>
            <a:picLocks noChangeAspect="1"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357" y="7476215"/>
            <a:ext cx="1619854" cy="121023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xmlns="" id="{7EBDE4B0-84D8-4C80-831D-C09C1AABDDC6}"/>
              </a:ext>
            </a:extLst>
          </p:cNvPr>
          <p:cNvPicPr>
            <a:picLocks noChangeAspect="1"/>
          </p:cNvPicPr>
          <p:nvPr/>
        </p:nvPicPr>
        <p:blipFill>
          <a:blip r:embed="rId1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461" y="7460177"/>
            <a:ext cx="1619854" cy="121023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250ACA11-3366-44E5-9008-A70D286DD3EE}"/>
              </a:ext>
            </a:extLst>
          </p:cNvPr>
          <p:cNvSpPr txBox="1"/>
          <p:nvPr/>
        </p:nvSpPr>
        <p:spPr>
          <a:xfrm>
            <a:off x="0" y="8686453"/>
            <a:ext cx="4099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Wagner </a:t>
            </a:r>
            <a:r>
              <a:rPr lang="en-US" b="1" i="1" dirty="0"/>
              <a:t>et al</a:t>
            </a:r>
            <a:r>
              <a:rPr lang="en-US" b="1" dirty="0"/>
              <a:t>., Supplemental Figure 10</a:t>
            </a:r>
          </a:p>
        </p:txBody>
      </p:sp>
    </p:spTree>
    <p:extLst>
      <p:ext uri="{BB962C8B-B14F-4D97-AF65-F5344CB8AC3E}">
        <p14:creationId xmlns:p14="http://schemas.microsoft.com/office/powerpoint/2010/main" val="376354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6</TotalTime>
  <Words>83</Words>
  <Application>Microsoft Office PowerPoint</Application>
  <PresentationFormat>Letter Paper (8.5x11 in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evilla, Hernando Jr.</cp:lastModifiedBy>
  <cp:revision>21</cp:revision>
  <dcterms:created xsi:type="dcterms:W3CDTF">2017-08-21T16:00:13Z</dcterms:created>
  <dcterms:modified xsi:type="dcterms:W3CDTF">2018-01-15T02:11:06Z</dcterms:modified>
</cp:coreProperties>
</file>